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870EB-7B6B-4442-96E7-0C618B9744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3E88B-40A1-4715-A0EF-59E4798262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F12B9-7BF3-4D23-AD39-106B4011E3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04925-50C3-4B64-A927-4AABAEFF18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CC95F-F7A6-4168-A7DA-419C82A8F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C71EA-E288-4E0E-A0C3-258A68E3D1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7A04B-0BEE-4B4C-9E34-C383E3E08E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3F039-E026-472F-9AFE-B7CC4E031C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B0C60-643C-4FFB-A0BF-D502FBA80B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688B8-884A-44EB-B7D8-C01B894FB7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7FA9A-B9DC-4DA7-A79F-10E9836FD5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617B5-A10B-4D70-BC2E-F549FDFD97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218D79-EC4B-49B0-A7C1-01ACC557B9C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5"/>
          <p:cNvSpPr/>
          <p:nvPr/>
        </p:nvSpPr>
        <p:spPr>
          <a:xfrm>
            <a:off x="250920" y="4724280"/>
            <a:ext cx="86421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3: Scout pools help filtering result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50.1% of off target variants and 23.3% of variations in low covered regions (less than 500x) are not detected in scout pools.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Grafico 5" descr=""/>
          <p:cNvPicPr/>
          <p:nvPr/>
        </p:nvPicPr>
        <p:blipFill>
          <a:blip r:embed="rId1"/>
          <a:stretch/>
        </p:blipFill>
        <p:spPr>
          <a:xfrm>
            <a:off x="1689120" y="682560"/>
            <a:ext cx="5838840" cy="404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5T10:39:59Z</dcterms:created>
  <dc:creator>LabN</dc:creator>
  <dc:description/>
  <dc:language>en-US</dc:language>
  <cp:lastModifiedBy>LabN</cp:lastModifiedBy>
  <dcterms:modified xsi:type="dcterms:W3CDTF">2014-07-30T11:54:42Z</dcterms:modified>
  <cp:revision>8</cp:revision>
  <dc:subject/>
  <dc:title>Diapositiva 1</dc:title>
</cp:coreProperties>
</file>